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0615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1842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8129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504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4081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38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5538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81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451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9653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1638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1FE14-7EE6-4375-BB93-4EB93AE1735F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985BF-81CA-4043-97ED-3A3698E7FF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26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1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microsoft.com/office/2007/relationships/hdphoto" Target="../media/hdphoto1.wdp"/><Relationship Id="rId7" Type="http://schemas.openxmlformats.org/officeDocument/2006/relationships/image" Target="../media/image18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Rechteck 87"/>
          <p:cNvSpPr/>
          <p:nvPr/>
        </p:nvSpPr>
        <p:spPr>
          <a:xfrm>
            <a:off x="760598" y="60619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cxnSp>
        <p:nvCxnSpPr>
          <p:cNvPr id="94" name="Gerade Verbindung 5"/>
          <p:cNvCxnSpPr/>
          <p:nvPr/>
        </p:nvCxnSpPr>
        <p:spPr>
          <a:xfrm flipH="1" flipV="1">
            <a:off x="5432555" y="1025334"/>
            <a:ext cx="569285" cy="947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95" name="Textfeld 94"/>
          <p:cNvSpPr txBox="1"/>
          <p:nvPr/>
        </p:nvSpPr>
        <p:spPr>
          <a:xfrm>
            <a:off x="5515866" y="896382"/>
            <a:ext cx="6102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-IP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Gerade Verbindung 74"/>
          <p:cNvCxnSpPr/>
          <p:nvPr/>
        </p:nvCxnSpPr>
        <p:spPr>
          <a:xfrm flipH="1">
            <a:off x="5011037" y="1023068"/>
            <a:ext cx="371116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97" name="Textfeld 96"/>
          <p:cNvSpPr txBox="1"/>
          <p:nvPr/>
        </p:nvSpPr>
        <p:spPr>
          <a:xfrm>
            <a:off x="4953515" y="896382"/>
            <a:ext cx="5807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Grafik 9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08" t="27142" r="35362" b="69395"/>
          <a:stretch/>
        </p:blipFill>
        <p:spPr>
          <a:xfrm>
            <a:off x="4948241" y="1156962"/>
            <a:ext cx="1234800" cy="82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Grafik 9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0" t="25769" r="36311" b="67805"/>
          <a:stretch/>
        </p:blipFill>
        <p:spPr>
          <a:xfrm>
            <a:off x="4948241" y="1239812"/>
            <a:ext cx="1234800" cy="152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Grafik 99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23" t="30962" r="31449" b="50000"/>
          <a:stretch/>
        </p:blipFill>
        <p:spPr>
          <a:xfrm>
            <a:off x="4948241" y="1825786"/>
            <a:ext cx="1234800" cy="4527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1" name="Grafik 10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82" t="46539" r="30389" b="47284"/>
          <a:stretch/>
        </p:blipFill>
        <p:spPr>
          <a:xfrm>
            <a:off x="4948241" y="1413965"/>
            <a:ext cx="1234800" cy="1468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" name="Grafik 10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29" t="30961" r="32943" b="59400"/>
          <a:stretch/>
        </p:blipFill>
        <p:spPr>
          <a:xfrm>
            <a:off x="4948241" y="1578640"/>
            <a:ext cx="1234800" cy="2292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3" name="Grafik 10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57" t="36414" r="36415" b="58394"/>
          <a:stretch/>
        </p:blipFill>
        <p:spPr>
          <a:xfrm>
            <a:off x="4948241" y="2296892"/>
            <a:ext cx="1234800" cy="123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4" name="Grafik 10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62" t="25769" r="57555" b="69491"/>
          <a:stretch/>
        </p:blipFill>
        <p:spPr>
          <a:xfrm>
            <a:off x="4948241" y="2440105"/>
            <a:ext cx="543204" cy="11442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05" name="Tabelle 10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3615713"/>
              </p:ext>
            </p:extLst>
          </p:nvPr>
        </p:nvGraphicFramePr>
        <p:xfrm>
          <a:off x="4948241" y="1061279"/>
          <a:ext cx="1234800" cy="914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623194794"/>
                    </a:ext>
                  </a:extLst>
                </a:gridCol>
              </a:tblGrid>
              <a:tr h="28518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06" name="Textfeld 105"/>
          <p:cNvSpPr txBox="1"/>
          <p:nvPr/>
        </p:nvSpPr>
        <p:spPr>
          <a:xfrm>
            <a:off x="6097606" y="1015924"/>
            <a:ext cx="10954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CD95L [min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6265546" y="1385847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6265546" y="1834193"/>
            <a:ext cx="4776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feld 108"/>
          <p:cNvSpPr txBox="1"/>
          <p:nvPr/>
        </p:nvSpPr>
        <p:spPr>
          <a:xfrm>
            <a:off x="6265546" y="1760166"/>
            <a:ext cx="4776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feld 109"/>
          <p:cNvSpPr txBox="1"/>
          <p:nvPr/>
        </p:nvSpPr>
        <p:spPr>
          <a:xfrm>
            <a:off x="6265546" y="2022972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6265546" y="1553105"/>
            <a:ext cx="8306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6265546" y="2410583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Gerade Verbindung mit Pfeil 112"/>
          <p:cNvCxnSpPr/>
          <p:nvPr/>
        </p:nvCxnSpPr>
        <p:spPr>
          <a:xfrm flipH="1">
            <a:off x="6190840" y="186084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mit Pfeil 113"/>
          <p:cNvCxnSpPr/>
          <p:nvPr/>
        </p:nvCxnSpPr>
        <p:spPr>
          <a:xfrm flipH="1">
            <a:off x="6190840" y="19364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mit Pfeil 114"/>
          <p:cNvCxnSpPr/>
          <p:nvPr/>
        </p:nvCxnSpPr>
        <p:spPr>
          <a:xfrm flipH="1">
            <a:off x="6190840" y="211663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 Verbindung mit Pfeil 115"/>
          <p:cNvCxnSpPr/>
          <p:nvPr/>
        </p:nvCxnSpPr>
        <p:spPr>
          <a:xfrm flipH="1">
            <a:off x="6190840" y="23469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rade Verbindung mit Pfeil 116"/>
          <p:cNvCxnSpPr/>
          <p:nvPr/>
        </p:nvCxnSpPr>
        <p:spPr>
          <a:xfrm flipH="1">
            <a:off x="6190840" y="163910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Gerade Verbindung mit Pfeil 117"/>
          <p:cNvCxnSpPr/>
          <p:nvPr/>
        </p:nvCxnSpPr>
        <p:spPr>
          <a:xfrm flipH="1">
            <a:off x="6190840" y="166398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Gerade Verbindung mit Pfeil 118"/>
          <p:cNvCxnSpPr/>
          <p:nvPr/>
        </p:nvCxnSpPr>
        <p:spPr>
          <a:xfrm flipH="1">
            <a:off x="6190840" y="25061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Gerade Verbindung mit Pfeil 119"/>
          <p:cNvCxnSpPr/>
          <p:nvPr/>
        </p:nvCxnSpPr>
        <p:spPr>
          <a:xfrm flipH="1">
            <a:off x="6190840" y="147774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 Verbindung mit Pfeil 120"/>
          <p:cNvCxnSpPr/>
          <p:nvPr/>
        </p:nvCxnSpPr>
        <p:spPr>
          <a:xfrm flipH="1">
            <a:off x="6190840" y="238502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feld 121"/>
          <p:cNvSpPr txBox="1"/>
          <p:nvPr/>
        </p:nvSpPr>
        <p:spPr>
          <a:xfrm>
            <a:off x="6265546" y="1099761"/>
            <a:ext cx="6554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Gerade Verbindung mit Pfeil 122"/>
          <p:cNvCxnSpPr/>
          <p:nvPr/>
        </p:nvCxnSpPr>
        <p:spPr>
          <a:xfrm flipH="1">
            <a:off x="6190840" y="119448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feld 123"/>
          <p:cNvSpPr txBox="1"/>
          <p:nvPr/>
        </p:nvSpPr>
        <p:spPr>
          <a:xfrm>
            <a:off x="6265546" y="1207917"/>
            <a:ext cx="750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Gerade Verbindung mit Pfeil 124"/>
          <p:cNvCxnSpPr/>
          <p:nvPr/>
        </p:nvCxnSpPr>
        <p:spPr>
          <a:xfrm flipH="1">
            <a:off x="6190840" y="130264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feld 125"/>
          <p:cNvSpPr txBox="1"/>
          <p:nvPr/>
        </p:nvSpPr>
        <p:spPr>
          <a:xfrm>
            <a:off x="6265546" y="2273148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9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6263058" y="2143682"/>
            <a:ext cx="379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22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Gerade Verbindung mit Pfeil 127"/>
          <p:cNvCxnSpPr/>
          <p:nvPr/>
        </p:nvCxnSpPr>
        <p:spPr>
          <a:xfrm flipH="1">
            <a:off x="6188351" y="22459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feld 128"/>
          <p:cNvSpPr txBox="1"/>
          <p:nvPr/>
        </p:nvSpPr>
        <p:spPr>
          <a:xfrm>
            <a:off x="6265116" y="1664328"/>
            <a:ext cx="4780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Gerade Verbindung mit Pfeil 129"/>
          <p:cNvCxnSpPr/>
          <p:nvPr/>
        </p:nvCxnSpPr>
        <p:spPr>
          <a:xfrm flipH="1">
            <a:off x="6188620" y="175400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Gerade Verbindung mit Pfeil 130"/>
          <p:cNvCxnSpPr/>
          <p:nvPr/>
        </p:nvCxnSpPr>
        <p:spPr>
          <a:xfrm flipH="1">
            <a:off x="6188620" y="17728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2" name="Gruppieren 131"/>
          <p:cNvGrpSpPr/>
          <p:nvPr/>
        </p:nvGrpSpPr>
        <p:grpSpPr>
          <a:xfrm>
            <a:off x="4424859" y="1021404"/>
            <a:ext cx="586987" cy="1666446"/>
            <a:chOff x="4321652" y="1107021"/>
            <a:chExt cx="457572" cy="1666446"/>
          </a:xfrm>
        </p:grpSpPr>
        <p:sp>
          <p:nvSpPr>
            <p:cNvPr id="133" name="Textfeld 132"/>
            <p:cNvSpPr txBox="1"/>
            <p:nvPr/>
          </p:nvSpPr>
          <p:spPr>
            <a:xfrm>
              <a:off x="4441988" y="1211824"/>
              <a:ext cx="33723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8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feld 133"/>
            <p:cNvSpPr txBox="1"/>
            <p:nvPr/>
          </p:nvSpPr>
          <p:spPr>
            <a:xfrm>
              <a:off x="4321652" y="1107021"/>
              <a:ext cx="4575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[</a:t>
              </a:r>
              <a:r>
                <a:rPr lang="de-DE" sz="6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4510668" y="1343592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8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feld 135"/>
            <p:cNvSpPr txBox="1"/>
            <p:nvPr/>
          </p:nvSpPr>
          <p:spPr>
            <a:xfrm>
              <a:off x="4510668" y="1871167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feld 136"/>
            <p:cNvSpPr txBox="1"/>
            <p:nvPr/>
          </p:nvSpPr>
          <p:spPr>
            <a:xfrm>
              <a:off x="4368820" y="1673813"/>
              <a:ext cx="4104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/53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feld 137"/>
            <p:cNvSpPr txBox="1"/>
            <p:nvPr/>
          </p:nvSpPr>
          <p:spPr>
            <a:xfrm>
              <a:off x="4510668" y="2496468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4510668" y="2394032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feld 139"/>
            <p:cNvSpPr txBox="1"/>
            <p:nvPr/>
          </p:nvSpPr>
          <p:spPr>
            <a:xfrm>
              <a:off x="4510668" y="2342596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feld 140"/>
            <p:cNvSpPr txBox="1"/>
            <p:nvPr/>
          </p:nvSpPr>
          <p:spPr>
            <a:xfrm>
              <a:off x="4510668" y="1512473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feld 141"/>
            <p:cNvSpPr txBox="1"/>
            <p:nvPr/>
          </p:nvSpPr>
          <p:spPr>
            <a:xfrm>
              <a:off x="4510668" y="2166996"/>
              <a:ext cx="268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3" name="Textfeld 142"/>
          <p:cNvSpPr txBox="1"/>
          <p:nvPr/>
        </p:nvSpPr>
        <p:spPr>
          <a:xfrm>
            <a:off x="5271116" y="788918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feld 143"/>
          <p:cNvSpPr txBox="1"/>
          <p:nvPr/>
        </p:nvSpPr>
        <p:spPr>
          <a:xfrm>
            <a:off x="6098608" y="181385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323833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08" t="27142" r="35362" b="69395"/>
          <a:stretch/>
        </p:blipFill>
        <p:spPr>
          <a:xfrm>
            <a:off x="733771" y="221010"/>
            <a:ext cx="1234800" cy="82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0" t="25769" r="36311" b="67805"/>
          <a:stretch/>
        </p:blipFill>
        <p:spPr>
          <a:xfrm>
            <a:off x="6008639" y="256188"/>
            <a:ext cx="1234800" cy="1528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feld 29"/>
          <p:cNvSpPr txBox="1"/>
          <p:nvPr/>
        </p:nvSpPr>
        <p:spPr>
          <a:xfrm>
            <a:off x="2051076" y="163809"/>
            <a:ext cx="6554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Gerade Verbindung mit Pfeil 30"/>
          <p:cNvCxnSpPr/>
          <p:nvPr/>
        </p:nvCxnSpPr>
        <p:spPr>
          <a:xfrm flipH="1">
            <a:off x="1976370" y="2585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7325944" y="224293"/>
            <a:ext cx="7505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 flipH="1">
            <a:off x="7251238" y="31902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" name="Grafik 5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035" b="23266"/>
          <a:stretch/>
        </p:blipFill>
        <p:spPr>
          <a:xfrm>
            <a:off x="4687644" y="3484901"/>
            <a:ext cx="4348779" cy="3192524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2" t="20957" r="25066" b="21420"/>
          <a:stretch/>
        </p:blipFill>
        <p:spPr>
          <a:xfrm>
            <a:off x="460635" y="780313"/>
            <a:ext cx="3319502" cy="2397418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95" b="22158"/>
          <a:stretch/>
        </p:blipFill>
        <p:spPr>
          <a:xfrm>
            <a:off x="169852" y="3484901"/>
            <a:ext cx="4417935" cy="3238628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1" t="10615" r="24927" b="25112"/>
          <a:stretch/>
        </p:blipFill>
        <p:spPr>
          <a:xfrm>
            <a:off x="5524820" y="503687"/>
            <a:ext cx="3150454" cy="2674044"/>
          </a:xfrm>
          <a:prstGeom prst="rect">
            <a:avLst/>
          </a:prstGeom>
        </p:spPr>
      </p:pic>
      <p:sp>
        <p:nvSpPr>
          <p:cNvPr id="57" name="Rechteck 56"/>
          <p:cNvSpPr/>
          <p:nvPr/>
        </p:nvSpPr>
        <p:spPr>
          <a:xfrm>
            <a:off x="530077" y="347746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330292" y="41871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330292" y="42745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330292" y="43659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330292" y="44665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330292" y="46901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330292" y="49025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330292" y="52667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330292" y="54505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330292" y="57681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330292" y="40655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1020777" y="399324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9" name="Rechteck 68"/>
          <p:cNvSpPr/>
          <p:nvPr/>
        </p:nvSpPr>
        <p:spPr>
          <a:xfrm>
            <a:off x="1008271" y="1034045"/>
            <a:ext cx="2188287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0" name="Rechteck 69"/>
          <p:cNvSpPr/>
          <p:nvPr/>
        </p:nvSpPr>
        <p:spPr>
          <a:xfrm>
            <a:off x="330292" y="60290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062376" y="348490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4862591" y="41945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4862591" y="42819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4862591" y="43733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4862591" y="44740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4862591" y="46976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4862591" y="49100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4862591" y="52742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4862591" y="54580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4862591" y="57755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4862591" y="40729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5553076" y="400068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3" name="Rechteck 82"/>
          <p:cNvSpPr/>
          <p:nvPr/>
        </p:nvSpPr>
        <p:spPr>
          <a:xfrm>
            <a:off x="5888162" y="1190869"/>
            <a:ext cx="2188287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Rechteck 83"/>
          <p:cNvSpPr/>
          <p:nvPr/>
        </p:nvSpPr>
        <p:spPr>
          <a:xfrm>
            <a:off x="4862591" y="60364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71339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82" t="46539" r="30389" b="47284"/>
          <a:stretch/>
        </p:blipFill>
        <p:spPr>
          <a:xfrm>
            <a:off x="793824" y="269035"/>
            <a:ext cx="1234800" cy="1468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29" t="30961" r="32943" b="59400"/>
          <a:stretch/>
        </p:blipFill>
        <p:spPr>
          <a:xfrm>
            <a:off x="5885694" y="218210"/>
            <a:ext cx="1234800" cy="2292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2111129" y="240917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202999" y="192675"/>
            <a:ext cx="8306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7128293" y="27867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7128293" y="30355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2036423" y="33281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7202569" y="303898"/>
            <a:ext cx="4780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 Verbindung mit Pfeil 25"/>
          <p:cNvCxnSpPr/>
          <p:nvPr/>
        </p:nvCxnSpPr>
        <p:spPr>
          <a:xfrm flipH="1">
            <a:off x="7126073" y="3935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7126073" y="41241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84" t="24097" r="26305" b="20680"/>
          <a:stretch/>
        </p:blipFill>
        <p:spPr>
          <a:xfrm>
            <a:off x="864645" y="887440"/>
            <a:ext cx="2912249" cy="2297526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7" t="4063" r="19556" b="20127"/>
          <a:stretch/>
        </p:blipFill>
        <p:spPr>
          <a:xfrm>
            <a:off x="184801" y="3554058"/>
            <a:ext cx="4271938" cy="3154104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5" t="14308" r="22861" b="27330"/>
          <a:stretch/>
        </p:blipFill>
        <p:spPr>
          <a:xfrm>
            <a:off x="5282580" y="705616"/>
            <a:ext cx="3004458" cy="2428154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657" b="25113"/>
          <a:stretch/>
        </p:blipFill>
        <p:spPr>
          <a:xfrm>
            <a:off x="4572000" y="3573268"/>
            <a:ext cx="4425619" cy="3115684"/>
          </a:xfrm>
          <a:prstGeom prst="rect">
            <a:avLst/>
          </a:prstGeom>
        </p:spPr>
      </p:pic>
      <p:sp>
        <p:nvSpPr>
          <p:cNvPr id="33" name="Rechteck 32"/>
          <p:cNvSpPr/>
          <p:nvPr/>
        </p:nvSpPr>
        <p:spPr>
          <a:xfrm>
            <a:off x="729862" y="381034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729862" y="44262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729862" y="45136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729862" y="46050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729862" y="47056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729862" y="49292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729862" y="51416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729862" y="55058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729862" y="56896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729862" y="60072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729862" y="43046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420347" y="423231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1362059" y="1839636"/>
            <a:ext cx="2188287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Rechteck 45"/>
          <p:cNvSpPr/>
          <p:nvPr/>
        </p:nvSpPr>
        <p:spPr>
          <a:xfrm>
            <a:off x="729862" y="62681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32321" y="381644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32321" y="44323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32321" y="45197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32321" y="46111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32321" y="47117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232321" y="49353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232321" y="51477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232321" y="55119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232321" y="5695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232321" y="60133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232321" y="43107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5922806" y="423841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9" name="Rechteck 58"/>
          <p:cNvSpPr/>
          <p:nvPr/>
        </p:nvSpPr>
        <p:spPr>
          <a:xfrm>
            <a:off x="5549473" y="1449842"/>
            <a:ext cx="2188287" cy="3897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Rechteck 59"/>
          <p:cNvSpPr/>
          <p:nvPr/>
        </p:nvSpPr>
        <p:spPr>
          <a:xfrm>
            <a:off x="5232321" y="62742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5930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23" t="30962" r="31449" b="50000"/>
          <a:stretch/>
        </p:blipFill>
        <p:spPr>
          <a:xfrm>
            <a:off x="767172" y="189087"/>
            <a:ext cx="1234800" cy="4527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57" t="36414" r="36415" b="58394"/>
          <a:stretch/>
        </p:blipFill>
        <p:spPr>
          <a:xfrm>
            <a:off x="6415892" y="211250"/>
            <a:ext cx="1234800" cy="1234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2084477" y="197494"/>
            <a:ext cx="4776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084477" y="123467"/>
            <a:ext cx="4776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084477" y="386273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2009771" y="22414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2009771" y="29975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2009771" y="4799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7658491" y="26128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>
            <a:off x="7658491" y="29938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7730499" y="189087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9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081989" y="506983"/>
            <a:ext cx="3792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22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2007282" y="60924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1917539" y="177156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48" r="25066" b="22527"/>
          <a:stretch/>
        </p:blipFill>
        <p:spPr>
          <a:xfrm>
            <a:off x="4893288" y="3493806"/>
            <a:ext cx="3680652" cy="3223260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18" t="15971" r="25341" b="23082"/>
          <a:stretch/>
        </p:blipFill>
        <p:spPr>
          <a:xfrm>
            <a:off x="5492643" y="445948"/>
            <a:ext cx="3081297" cy="2535731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95" b="26221"/>
          <a:stretch/>
        </p:blipFill>
        <p:spPr>
          <a:xfrm>
            <a:off x="252311" y="3646988"/>
            <a:ext cx="4417935" cy="3069579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9" t="11908" r="21071" b="25297"/>
          <a:stretch/>
        </p:blipFill>
        <p:spPr>
          <a:xfrm>
            <a:off x="257799" y="881235"/>
            <a:ext cx="3050561" cy="2612571"/>
          </a:xfrm>
          <a:prstGeom prst="rect">
            <a:avLst/>
          </a:prstGeom>
        </p:spPr>
      </p:pic>
      <p:sp>
        <p:nvSpPr>
          <p:cNvPr id="23" name="Rechteck 22"/>
          <p:cNvSpPr/>
          <p:nvPr/>
        </p:nvSpPr>
        <p:spPr>
          <a:xfrm>
            <a:off x="981609" y="385644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981609" y="44723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981609" y="4559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981609" y="4651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981609" y="4751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981609" y="49753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981609" y="51877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981609" y="55519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981609" y="57357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981609" y="60533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981609" y="43507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672094" y="427842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5" name="Rechteck 34"/>
          <p:cNvSpPr/>
          <p:nvPr/>
        </p:nvSpPr>
        <p:spPr>
          <a:xfrm>
            <a:off x="577950" y="1682277"/>
            <a:ext cx="2188287" cy="837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6" name="Rechteck 35"/>
          <p:cNvSpPr/>
          <p:nvPr/>
        </p:nvSpPr>
        <p:spPr>
          <a:xfrm>
            <a:off x="981609" y="63142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4838007" y="385644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4838007" y="44723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4838007" y="4559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4838007" y="4651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838007" y="4751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4838007" y="49753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4838007" y="51877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4838007" y="55519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4838007" y="57357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4838007" y="60533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4838007" y="43507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528492" y="427842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9" name="Rechteck 48"/>
          <p:cNvSpPr/>
          <p:nvPr/>
        </p:nvSpPr>
        <p:spPr>
          <a:xfrm>
            <a:off x="5785249" y="1280387"/>
            <a:ext cx="2188287" cy="2871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0" name="Rechteck 49"/>
          <p:cNvSpPr/>
          <p:nvPr/>
        </p:nvSpPr>
        <p:spPr>
          <a:xfrm>
            <a:off x="4838007" y="63142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8579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62" t="25769" r="57555" b="69491"/>
          <a:stretch/>
        </p:blipFill>
        <p:spPr>
          <a:xfrm>
            <a:off x="960228" y="234788"/>
            <a:ext cx="543204" cy="1144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2277533" y="205266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2202827" y="30080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861" b="32316"/>
          <a:stretch/>
        </p:blipFill>
        <p:spPr>
          <a:xfrm>
            <a:off x="730368" y="3500269"/>
            <a:ext cx="4302675" cy="2816006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1" t="4520" r="22173" b="33424"/>
          <a:stretch/>
        </p:blipFill>
        <p:spPr>
          <a:xfrm>
            <a:off x="829233" y="553250"/>
            <a:ext cx="3273399" cy="2581835"/>
          </a:xfrm>
          <a:prstGeom prst="rect">
            <a:avLst/>
          </a:prstGeom>
        </p:spPr>
      </p:pic>
      <p:sp>
        <p:nvSpPr>
          <p:cNvPr id="7" name="Rechteck 6"/>
          <p:cNvSpPr/>
          <p:nvPr/>
        </p:nvSpPr>
        <p:spPr>
          <a:xfrm>
            <a:off x="1221640" y="344919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1221640" y="39344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221640" y="40218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221640" y="41132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221640" y="42138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221640" y="44374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221640" y="46498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221640" y="50140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221640" y="51978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221640" y="55154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221640" y="38128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912125" y="374053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9" name="Rechteck 18"/>
          <p:cNvSpPr/>
          <p:nvPr/>
        </p:nvSpPr>
        <p:spPr>
          <a:xfrm>
            <a:off x="1221640" y="1426506"/>
            <a:ext cx="876101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Rechteck 19"/>
          <p:cNvSpPr/>
          <p:nvPr/>
        </p:nvSpPr>
        <p:spPr>
          <a:xfrm>
            <a:off x="1221640" y="57763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2631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1</Words>
  <Application>Microsoft Office PowerPoint</Application>
  <PresentationFormat>Bildschirmpräsentation (4:3)</PresentationFormat>
  <Paragraphs>137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8</cp:revision>
  <dcterms:created xsi:type="dcterms:W3CDTF">2024-08-22T14:32:22Z</dcterms:created>
  <dcterms:modified xsi:type="dcterms:W3CDTF">2024-08-23T12:06:54Z</dcterms:modified>
</cp:coreProperties>
</file>